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48" d="100"/>
          <a:sy n="48" d="100"/>
        </p:scale>
        <p:origin x="2304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159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2673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3025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4951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7921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2145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3382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17977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5644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5125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5100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48003-700C-40C0-83CD-9567DB674CAD}" type="datetimeFigureOut">
              <a:rPr lang="fr-FR" smtClean="0"/>
              <a:t>20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D8383-0046-4FD1-A1E1-F1D24407DF0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7325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 3"/>
          <p:cNvGraphicFramePr>
            <a:graphicFrameLocks noChangeAspect="1"/>
          </p:cNvGraphicFramePr>
          <p:nvPr>
            <p:extLst/>
          </p:nvPr>
        </p:nvGraphicFramePr>
        <p:xfrm>
          <a:off x="1659055" y="1160362"/>
          <a:ext cx="3151051" cy="22466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5" r:id="rId3" imgW="4130036" imgH="2941018" progId="Prism5.Document">
                  <p:embed/>
                </p:oleObj>
              </mc:Choice>
              <mc:Fallback>
                <p:oleObj name="Prism 5" r:id="rId3" imgW="4130036" imgH="2941018" progId="Prism5.Document">
                  <p:embed/>
                  <p:pic>
                    <p:nvPicPr>
                      <p:cNvPr id="4" name="Obje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59055" y="1160362"/>
                        <a:ext cx="3151051" cy="22466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1" y="341100"/>
            <a:ext cx="2846768" cy="3715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814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FR" sz="1814" b="1" dirty="0">
                <a:latin typeface="Arial" panose="020B0604020202020204" pitchFamily="34" charset="0"/>
                <a:cs typeface="Arial" panose="020B0604020202020204" pitchFamily="34" charset="0"/>
              </a:rPr>
              <a:t> data </a:t>
            </a:r>
            <a:r>
              <a:rPr lang="fr-FR" sz="1814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fr-FR" sz="1814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t 5"/>
          <p:cNvGraphicFramePr>
            <a:graphicFrameLocks noChangeAspect="1"/>
          </p:cNvGraphicFramePr>
          <p:nvPr>
            <p:extLst/>
          </p:nvPr>
        </p:nvGraphicFramePr>
        <p:xfrm>
          <a:off x="1693618" y="3406998"/>
          <a:ext cx="3116487" cy="22639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5" r:id="rId5" imgW="4006510" imgH="2913646" progId="Prism5.Document">
                  <p:embed/>
                </p:oleObj>
              </mc:Choice>
              <mc:Fallback>
                <p:oleObj name="Prism 5" r:id="rId5" imgW="4006510" imgH="2913646" progId="Prism5.Document">
                  <p:embed/>
                  <p:pic>
                    <p:nvPicPr>
                      <p:cNvPr id="6" name="Objet 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93618" y="3406998"/>
                        <a:ext cx="3116487" cy="22639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ZoneTexte 6"/>
          <p:cNvSpPr txBox="1"/>
          <p:nvPr/>
        </p:nvSpPr>
        <p:spPr>
          <a:xfrm>
            <a:off x="1209232" y="1160362"/>
            <a:ext cx="449823" cy="3715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81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1209232" y="3406998"/>
            <a:ext cx="449823" cy="3715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81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811524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1" y="341100"/>
            <a:ext cx="7096404" cy="8912836"/>
            <a:chOff x="0" y="262140"/>
            <a:chExt cx="7822471" cy="9824751"/>
          </a:xfrm>
        </p:grpSpPr>
        <p:sp>
          <p:nvSpPr>
            <p:cNvPr id="5" name="ZoneTexte 4"/>
            <p:cNvSpPr txBox="1"/>
            <p:nvPr/>
          </p:nvSpPr>
          <p:spPr>
            <a:xfrm>
              <a:off x="0" y="262140"/>
              <a:ext cx="3138036" cy="4095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814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upplemental</a:t>
              </a:r>
              <a:r>
                <a:rPr lang="fr-FR" sz="1814" b="1" dirty="0">
                  <a:latin typeface="Arial" panose="020B0604020202020204" pitchFamily="34" charset="0"/>
                  <a:cs typeface="Arial" panose="020B0604020202020204" pitchFamily="34" charset="0"/>
                </a:rPr>
                <a:t> data </a:t>
              </a:r>
              <a:r>
                <a:rPr lang="fr-FR" sz="1814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fr-FR" sz="1814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200761" y="676457"/>
              <a:ext cx="495847" cy="4095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814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3828561" y="676457"/>
              <a:ext cx="495847" cy="4095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814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10" name="Picture 11">
              <a:extLst>
                <a:ext uri="{FF2B5EF4-FFF2-40B4-BE49-F238E27FC236}">
                  <a16:creationId xmlns:a16="http://schemas.microsoft.com/office/drawing/2014/main" id="{1E9C874E-DCD9-4DD4-9CDF-43AEFCAD2D2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761" y="1181106"/>
              <a:ext cx="2383349" cy="228131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ZoneTexte 10"/>
            <p:cNvSpPr txBox="1"/>
            <p:nvPr/>
          </p:nvSpPr>
          <p:spPr>
            <a:xfrm>
              <a:off x="200761" y="3850974"/>
              <a:ext cx="495847" cy="4095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814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754624" y="3862953"/>
              <a:ext cx="495847" cy="4095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814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00316" y="6995308"/>
              <a:ext cx="495847" cy="4095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814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042649" y="7295815"/>
              <a:ext cx="495847" cy="4095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814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pic>
          <p:nvPicPr>
            <p:cNvPr id="15" name="Picture 1">
              <a:extLst>
                <a:ext uri="{FF2B5EF4-FFF2-40B4-BE49-F238E27FC236}">
                  <a16:creationId xmlns:a16="http://schemas.microsoft.com/office/drawing/2014/main" id="{00000000-0008-0000-0000-00000200000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59161" y="1241673"/>
              <a:ext cx="2371725" cy="22955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7">
              <a:extLst>
                <a:ext uri="{FF2B5EF4-FFF2-40B4-BE49-F238E27FC236}">
                  <a16:creationId xmlns:a16="http://schemas.microsoft.com/office/drawing/2014/main" id="{B97DCF58-A16B-4106-A6B6-135BBEEBBD8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1460" y="4263063"/>
              <a:ext cx="2371725" cy="22955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15">
              <a:extLst>
                <a:ext uri="{FF2B5EF4-FFF2-40B4-BE49-F238E27FC236}">
                  <a16:creationId xmlns:a16="http://schemas.microsoft.com/office/drawing/2014/main" id="{3762AED0-1634-44D2-A207-B293503B6B2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50746" y="4300491"/>
              <a:ext cx="2371725" cy="22955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" name="Picture 10">
              <a:extLst>
                <a:ext uri="{FF2B5EF4-FFF2-40B4-BE49-F238E27FC236}">
                  <a16:creationId xmlns:a16="http://schemas.microsoft.com/office/drawing/2014/main" id="{180ED232-74DD-4CD2-85F4-DBA42BDEC0E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02821" y="4300491"/>
              <a:ext cx="2371725" cy="22955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14">
              <a:extLst>
                <a:ext uri="{FF2B5EF4-FFF2-40B4-BE49-F238E27FC236}">
                  <a16:creationId xmlns:a16="http://schemas.microsoft.com/office/drawing/2014/main" id="{AFE099A7-68D2-49F5-86A0-A45D39FD665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315" y="7526656"/>
              <a:ext cx="2371725" cy="22891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ZoneTexte 1"/>
            <p:cNvSpPr txBox="1"/>
            <p:nvPr/>
          </p:nvSpPr>
          <p:spPr>
            <a:xfrm rot="16200000">
              <a:off x="-214957" y="8535713"/>
              <a:ext cx="763704" cy="2710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98" dirty="0"/>
                <a:t>YO-PRO-1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1008260" y="9815831"/>
              <a:ext cx="535758" cy="27106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998" dirty="0"/>
                <a:t>M540</a:t>
              </a:r>
            </a:p>
          </p:txBody>
        </p:sp>
        <p:pic>
          <p:nvPicPr>
            <p:cNvPr id="22" name="Picture 8">
              <a:extLst>
                <a:ext uri="{FF2B5EF4-FFF2-40B4-BE49-F238E27FC236}">
                  <a16:creationId xmlns:a16="http://schemas.microsoft.com/office/drawing/2014/main" id="{F3EF5B48-3FB0-40D3-A7B3-C6F050683B4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42649" y="7746160"/>
              <a:ext cx="2371725" cy="22891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Rectangle 22"/>
            <p:cNvSpPr/>
            <p:nvPr/>
          </p:nvSpPr>
          <p:spPr>
            <a:xfrm>
              <a:off x="3535500" y="6595223"/>
              <a:ext cx="1466976" cy="27106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98" dirty="0">
                  <a:latin typeface="Times New Roman" panose="02020603050405020304" pitchFamily="18" charset="0"/>
                  <a:ea typeface="Calibri" panose="020F0502020204030204" pitchFamily="34" charset="0"/>
                </a:rPr>
                <a:t>live sperm population </a:t>
              </a:r>
              <a:endParaRPr lang="fr-FR" sz="998" dirty="0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4684891" y="5529514"/>
              <a:ext cx="392631" cy="28653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89" b="1" dirty="0">
                  <a:latin typeface="Times New Roman" panose="02020603050405020304" pitchFamily="18" charset="0"/>
                </a:rPr>
                <a:t>R2</a:t>
              </a:r>
              <a:endParaRPr lang="fr-FR" sz="1089" b="1" dirty="0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5721089" y="6677037"/>
              <a:ext cx="1800908" cy="4403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998" dirty="0">
                  <a:latin typeface="Times New Roman" panose="02020603050405020304" pitchFamily="18" charset="0"/>
                  <a:ea typeface="Calibri" panose="020F0502020204030204" pitchFamily="34" charset="0"/>
                </a:rPr>
                <a:t>mitochondrial potential </a:t>
              </a:r>
              <a:r>
                <a:rPr lang="en-US" sz="998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analysed</a:t>
              </a:r>
              <a:r>
                <a:rPr lang="en-US" sz="998" dirty="0">
                  <a:latin typeface="Times New Roman" panose="02020603050405020304" pitchFamily="18" charset="0"/>
                  <a:ea typeface="Calibri" panose="020F0502020204030204" pitchFamily="34" charset="0"/>
                </a:rPr>
                <a:t> from gate R2</a:t>
              </a:r>
              <a:endParaRPr lang="fr-FR" sz="998" dirty="0"/>
            </a:p>
          </p:txBody>
        </p:sp>
      </p:grpSp>
    </p:spTree>
    <p:extLst>
      <p:ext uri="{BB962C8B-B14F-4D97-AF65-F5344CB8AC3E}">
        <p14:creationId xmlns:p14="http://schemas.microsoft.com/office/powerpoint/2010/main" val="25219978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6</Words>
  <Application>Microsoft Office PowerPoint</Application>
  <PresentationFormat>Format A4 (210 x 297 mm)</PresentationFormat>
  <Paragraphs>15</Paragraphs>
  <Slides>2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hème Office</vt:lpstr>
      <vt:lpstr>Prism 5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érémy Grandhaye</dc:creator>
  <cp:lastModifiedBy>adminposte</cp:lastModifiedBy>
  <cp:revision>1</cp:revision>
  <dcterms:created xsi:type="dcterms:W3CDTF">2020-01-20T16:28:28Z</dcterms:created>
  <dcterms:modified xsi:type="dcterms:W3CDTF">2020-01-20T16:52:08Z</dcterms:modified>
</cp:coreProperties>
</file>